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7772400" cy="10666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685800" y="5029200"/>
            <a:ext cx="77724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685800" y="5984640"/>
            <a:ext cx="77724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7772400" cy="10666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5029200"/>
            <a:ext cx="37926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668480" y="5029200"/>
            <a:ext cx="37926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685800" y="5984640"/>
            <a:ext cx="37926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4668480" y="5984640"/>
            <a:ext cx="37926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7772400" cy="10666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685800" y="5029200"/>
            <a:ext cx="250236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313800" y="5029200"/>
            <a:ext cx="250236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5941440" y="5029200"/>
            <a:ext cx="250236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685800" y="5984640"/>
            <a:ext cx="250236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313800" y="5984640"/>
            <a:ext cx="250236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5941440" y="5984640"/>
            <a:ext cx="250236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7772400" cy="10666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85800" y="502920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7772400" cy="10666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685800" y="502920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7772400" cy="10666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685800" y="5029200"/>
            <a:ext cx="3792600" cy="18288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4668480" y="5029200"/>
            <a:ext cx="3792600" cy="18288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7772400" cy="10666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09480" y="-360"/>
            <a:ext cx="7772400" cy="494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7772400" cy="10666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685800" y="5029200"/>
            <a:ext cx="37926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4668480" y="5029200"/>
            <a:ext cx="3792600" cy="18288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685800" y="5984640"/>
            <a:ext cx="37926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7772400" cy="10666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685800" y="5029200"/>
            <a:ext cx="3792600" cy="18288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68480" y="5029200"/>
            <a:ext cx="37926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668480" y="5984640"/>
            <a:ext cx="37926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7772400" cy="10666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685800" y="5029200"/>
            <a:ext cx="37926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68480" y="5029200"/>
            <a:ext cx="37926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685800" y="5984640"/>
            <a:ext cx="7772400" cy="8722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960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09480" y="-360"/>
            <a:ext cx="7772400" cy="106668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Comic Sans MS"/>
              </a:rPr>
              <a:t>Click to edit the title text format</a:t>
            </a: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502920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 fontScale="75000"/>
          </a:bodyPr>
          <a:p>
            <a:pPr marL="29520" indent="0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omic Sans MS"/>
              </a:rPr>
              <a:t>Click to edit the outline text format</a:t>
            </a: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  <a:p>
            <a:pPr lvl="1" marL="29520">
              <a:spcBef>
                <a:spcPts val="499"/>
              </a:spcBef>
              <a:buClr>
                <a:srgbClr val="ffffff"/>
              </a:buClr>
              <a:buFont typeface="Comic Sans MS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omic Sans MS"/>
              </a:rPr>
              <a:t>Second Outline Level</a:t>
            </a: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  <a:p>
            <a:pPr lvl="2" marL="29520">
              <a:spcBef>
                <a:spcPts val="499"/>
              </a:spcBef>
              <a:buClr>
                <a:srgbClr val="ffffff"/>
              </a:buClr>
              <a:buFont typeface="Comic Sans MS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omic Sans MS"/>
              </a:rPr>
              <a:t>Third Outline Level</a:t>
            </a: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  <a:p>
            <a:pPr lvl="3" marL="29520">
              <a:spcBef>
                <a:spcPts val="499"/>
              </a:spcBef>
              <a:buClr>
                <a:srgbClr val="ffffff"/>
              </a:buClr>
              <a:buFont typeface="Comic Sans MS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omic Sans MS"/>
              </a:rPr>
              <a:t>Fourth Outline Level</a:t>
            </a: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  <a:p>
            <a:pPr lvl="4" marL="29520">
              <a:spcBef>
                <a:spcPts val="499"/>
              </a:spcBef>
              <a:buClr>
                <a:srgbClr val="ffffff"/>
              </a:buClr>
              <a:buFont typeface="Comic Sans M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omic Sans MS"/>
              </a:rPr>
              <a:t>Fifth Outline Level</a:t>
            </a: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  <a:p>
            <a:pPr lvl="5" marL="29520">
              <a:spcBef>
                <a:spcPts val="499"/>
              </a:spcBef>
              <a:buClr>
                <a:srgbClr val="000000"/>
              </a:buClr>
              <a:buFont typeface="Comic Sans M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omic Sans MS"/>
              </a:rPr>
              <a:t>Sixth Outline Level</a:t>
            </a: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  <a:p>
            <a:pPr lvl="6" marL="29520">
              <a:spcBef>
                <a:spcPts val="499"/>
              </a:spcBef>
              <a:buClr>
                <a:srgbClr val="000000"/>
              </a:buClr>
              <a:buFont typeface="Comic Sans M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omic Sans MS"/>
              </a:rPr>
              <a:t>Seventh Outline Level</a:t>
            </a:r>
            <a:endParaRPr b="1" lang="en-US" sz="1800" spc="-1" strike="noStrike">
              <a:solidFill>
                <a:srgbClr val="ffffff"/>
              </a:solidFill>
              <a:latin typeface="Comic Sans M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"/>
          <p:cNvGrpSpPr/>
          <p:nvPr/>
        </p:nvGrpSpPr>
        <p:grpSpPr>
          <a:xfrm>
            <a:off x="258480" y="1434960"/>
            <a:ext cx="4934160" cy="5283360"/>
            <a:chOff x="258480" y="1434960"/>
            <a:chExt cx="4934160" cy="5283360"/>
          </a:xfrm>
        </p:grpSpPr>
        <p:sp>
          <p:nvSpPr>
            <p:cNvPr id="39" name=""/>
            <p:cNvSpPr/>
            <p:nvPr/>
          </p:nvSpPr>
          <p:spPr>
            <a:xfrm>
              <a:off x="1406520" y="1434960"/>
              <a:ext cx="3786120" cy="5283360"/>
            </a:xfrm>
            <a:custGeom>
              <a:avLst/>
              <a:gdLst/>
              <a:ahLst/>
              <a:rect l="l" t="t" r="r" b="b"/>
              <a:pathLst>
                <a:path w="2385" h="3328">
                  <a:moveTo>
                    <a:pt x="1866" y="3264"/>
                  </a:moveTo>
                  <a:cubicBezTo>
                    <a:pt x="1876" y="3266"/>
                    <a:pt x="1887" y="3268"/>
                    <a:pt x="1898" y="3272"/>
                  </a:cubicBezTo>
                  <a:cubicBezTo>
                    <a:pt x="1914" y="3276"/>
                    <a:pt x="1946" y="3288"/>
                    <a:pt x="1946" y="3288"/>
                  </a:cubicBezTo>
                  <a:cubicBezTo>
                    <a:pt x="1948" y="3296"/>
                    <a:pt x="1947" y="3307"/>
                    <a:pt x="1954" y="3312"/>
                  </a:cubicBezTo>
                  <a:cubicBezTo>
                    <a:pt x="1967" y="3321"/>
                    <a:pt x="2002" y="3328"/>
                    <a:pt x="2002" y="3328"/>
                  </a:cubicBezTo>
                  <a:cubicBezTo>
                    <a:pt x="2063" y="3325"/>
                    <a:pt x="2124" y="3324"/>
                    <a:pt x="2186" y="3320"/>
                  </a:cubicBezTo>
                  <a:cubicBezTo>
                    <a:pt x="2190" y="3319"/>
                    <a:pt x="2234" y="3308"/>
                    <a:pt x="2242" y="3304"/>
                  </a:cubicBezTo>
                  <a:cubicBezTo>
                    <a:pt x="2258" y="3294"/>
                    <a:pt x="2290" y="3272"/>
                    <a:pt x="2290" y="3272"/>
                  </a:cubicBezTo>
                  <a:cubicBezTo>
                    <a:pt x="2295" y="3256"/>
                    <a:pt x="2294" y="3235"/>
                    <a:pt x="2306" y="3224"/>
                  </a:cubicBezTo>
                  <a:cubicBezTo>
                    <a:pt x="2321" y="3208"/>
                    <a:pt x="2337" y="3196"/>
                    <a:pt x="2346" y="3176"/>
                  </a:cubicBezTo>
                  <a:cubicBezTo>
                    <a:pt x="2360" y="3142"/>
                    <a:pt x="2363" y="3122"/>
                    <a:pt x="2370" y="3088"/>
                  </a:cubicBezTo>
                  <a:cubicBezTo>
                    <a:pt x="2377" y="3002"/>
                    <a:pt x="2385" y="2926"/>
                    <a:pt x="2346" y="2848"/>
                  </a:cubicBezTo>
                  <a:cubicBezTo>
                    <a:pt x="2341" y="2693"/>
                    <a:pt x="2326" y="2538"/>
                    <a:pt x="2330" y="2384"/>
                  </a:cubicBezTo>
                  <a:cubicBezTo>
                    <a:pt x="2332" y="2286"/>
                    <a:pt x="2357" y="2192"/>
                    <a:pt x="2370" y="2096"/>
                  </a:cubicBezTo>
                  <a:cubicBezTo>
                    <a:pt x="2367" y="1957"/>
                    <a:pt x="2366" y="1818"/>
                    <a:pt x="2362" y="1680"/>
                  </a:cubicBezTo>
                  <a:cubicBezTo>
                    <a:pt x="2360" y="1633"/>
                    <a:pt x="2343" y="1589"/>
                    <a:pt x="2338" y="1544"/>
                  </a:cubicBezTo>
                  <a:cubicBezTo>
                    <a:pt x="2331" y="1492"/>
                    <a:pt x="2315" y="1449"/>
                    <a:pt x="2306" y="1400"/>
                  </a:cubicBezTo>
                  <a:cubicBezTo>
                    <a:pt x="2299" y="1369"/>
                    <a:pt x="2297" y="1307"/>
                    <a:pt x="2282" y="1280"/>
                  </a:cubicBezTo>
                  <a:cubicBezTo>
                    <a:pt x="2262" y="1245"/>
                    <a:pt x="2218" y="1215"/>
                    <a:pt x="2194" y="1184"/>
                  </a:cubicBezTo>
                  <a:cubicBezTo>
                    <a:pt x="2143" y="1119"/>
                    <a:pt x="2184" y="1150"/>
                    <a:pt x="2138" y="1120"/>
                  </a:cubicBezTo>
                  <a:cubicBezTo>
                    <a:pt x="2119" y="1064"/>
                    <a:pt x="2145" y="1126"/>
                    <a:pt x="2106" y="1080"/>
                  </a:cubicBezTo>
                  <a:cubicBezTo>
                    <a:pt x="2060" y="1026"/>
                    <a:pt x="2045" y="959"/>
                    <a:pt x="1986" y="920"/>
                  </a:cubicBezTo>
                  <a:cubicBezTo>
                    <a:pt x="1969" y="852"/>
                    <a:pt x="1992" y="921"/>
                    <a:pt x="1954" y="864"/>
                  </a:cubicBezTo>
                  <a:cubicBezTo>
                    <a:pt x="1949" y="856"/>
                    <a:pt x="1950" y="847"/>
                    <a:pt x="1946" y="840"/>
                  </a:cubicBezTo>
                  <a:cubicBezTo>
                    <a:pt x="1936" y="823"/>
                    <a:pt x="1927" y="805"/>
                    <a:pt x="1914" y="792"/>
                  </a:cubicBezTo>
                  <a:cubicBezTo>
                    <a:pt x="1906" y="784"/>
                    <a:pt x="1896" y="777"/>
                    <a:pt x="1890" y="768"/>
                  </a:cubicBezTo>
                  <a:cubicBezTo>
                    <a:pt x="1868" y="738"/>
                    <a:pt x="1860" y="714"/>
                    <a:pt x="1834" y="688"/>
                  </a:cubicBezTo>
                  <a:cubicBezTo>
                    <a:pt x="1818" y="640"/>
                    <a:pt x="1815" y="650"/>
                    <a:pt x="1778" y="624"/>
                  </a:cubicBezTo>
                  <a:cubicBezTo>
                    <a:pt x="1752" y="605"/>
                    <a:pt x="1736" y="574"/>
                    <a:pt x="1714" y="552"/>
                  </a:cubicBezTo>
                  <a:cubicBezTo>
                    <a:pt x="1698" y="506"/>
                    <a:pt x="1718" y="544"/>
                    <a:pt x="1682" y="520"/>
                  </a:cubicBezTo>
                  <a:cubicBezTo>
                    <a:pt x="1610" y="472"/>
                    <a:pt x="1722" y="517"/>
                    <a:pt x="1610" y="480"/>
                  </a:cubicBezTo>
                  <a:cubicBezTo>
                    <a:pt x="1604" y="472"/>
                    <a:pt x="1600" y="462"/>
                    <a:pt x="1594" y="456"/>
                  </a:cubicBezTo>
                  <a:cubicBezTo>
                    <a:pt x="1587" y="449"/>
                    <a:pt x="1576" y="447"/>
                    <a:pt x="1570" y="440"/>
                  </a:cubicBezTo>
                  <a:cubicBezTo>
                    <a:pt x="1525" y="384"/>
                    <a:pt x="1606" y="445"/>
                    <a:pt x="1538" y="400"/>
                  </a:cubicBezTo>
                  <a:cubicBezTo>
                    <a:pt x="1513" y="362"/>
                    <a:pt x="1484" y="358"/>
                    <a:pt x="1442" y="344"/>
                  </a:cubicBezTo>
                  <a:cubicBezTo>
                    <a:pt x="1434" y="341"/>
                    <a:pt x="1418" y="336"/>
                    <a:pt x="1418" y="336"/>
                  </a:cubicBezTo>
                  <a:cubicBezTo>
                    <a:pt x="1377" y="295"/>
                    <a:pt x="1346" y="248"/>
                    <a:pt x="1298" y="216"/>
                  </a:cubicBezTo>
                  <a:cubicBezTo>
                    <a:pt x="1262" y="163"/>
                    <a:pt x="1198" y="123"/>
                    <a:pt x="1146" y="88"/>
                  </a:cubicBezTo>
                  <a:cubicBezTo>
                    <a:pt x="1122" y="72"/>
                    <a:pt x="1101" y="49"/>
                    <a:pt x="1074" y="40"/>
                  </a:cubicBezTo>
                  <a:cubicBezTo>
                    <a:pt x="1029" y="25"/>
                    <a:pt x="988" y="21"/>
                    <a:pt x="946" y="0"/>
                  </a:cubicBezTo>
                  <a:cubicBezTo>
                    <a:pt x="866" y="5"/>
                    <a:pt x="838" y="1"/>
                    <a:pt x="770" y="24"/>
                  </a:cubicBezTo>
                  <a:cubicBezTo>
                    <a:pt x="754" y="29"/>
                    <a:pt x="722" y="40"/>
                    <a:pt x="722" y="40"/>
                  </a:cubicBezTo>
                  <a:cubicBezTo>
                    <a:pt x="719" y="48"/>
                    <a:pt x="719" y="58"/>
                    <a:pt x="714" y="64"/>
                  </a:cubicBezTo>
                  <a:cubicBezTo>
                    <a:pt x="700" y="77"/>
                    <a:pt x="666" y="96"/>
                    <a:pt x="666" y="96"/>
                  </a:cubicBezTo>
                  <a:cubicBezTo>
                    <a:pt x="644" y="128"/>
                    <a:pt x="633" y="167"/>
                    <a:pt x="610" y="200"/>
                  </a:cubicBezTo>
                  <a:cubicBezTo>
                    <a:pt x="603" y="209"/>
                    <a:pt x="592" y="215"/>
                    <a:pt x="586" y="224"/>
                  </a:cubicBezTo>
                  <a:cubicBezTo>
                    <a:pt x="574" y="239"/>
                    <a:pt x="563" y="255"/>
                    <a:pt x="554" y="272"/>
                  </a:cubicBezTo>
                  <a:cubicBezTo>
                    <a:pt x="512" y="341"/>
                    <a:pt x="474" y="415"/>
                    <a:pt x="426" y="480"/>
                  </a:cubicBezTo>
                  <a:cubicBezTo>
                    <a:pt x="415" y="511"/>
                    <a:pt x="392" y="530"/>
                    <a:pt x="378" y="560"/>
                  </a:cubicBezTo>
                  <a:cubicBezTo>
                    <a:pt x="365" y="585"/>
                    <a:pt x="359" y="615"/>
                    <a:pt x="346" y="640"/>
                  </a:cubicBezTo>
                  <a:cubicBezTo>
                    <a:pt x="317" y="691"/>
                    <a:pt x="284" y="745"/>
                    <a:pt x="250" y="792"/>
                  </a:cubicBezTo>
                  <a:cubicBezTo>
                    <a:pt x="240" y="830"/>
                    <a:pt x="248" y="843"/>
                    <a:pt x="210" y="856"/>
                  </a:cubicBezTo>
                  <a:cubicBezTo>
                    <a:pt x="185" y="930"/>
                    <a:pt x="228" y="806"/>
                    <a:pt x="178" y="920"/>
                  </a:cubicBezTo>
                  <a:cubicBezTo>
                    <a:pt x="173" y="930"/>
                    <a:pt x="174" y="941"/>
                    <a:pt x="170" y="952"/>
                  </a:cubicBezTo>
                  <a:cubicBezTo>
                    <a:pt x="153" y="990"/>
                    <a:pt x="129" y="1028"/>
                    <a:pt x="106" y="1064"/>
                  </a:cubicBezTo>
                  <a:cubicBezTo>
                    <a:pt x="86" y="1141"/>
                    <a:pt x="66" y="1215"/>
                    <a:pt x="18" y="1280"/>
                  </a:cubicBezTo>
                  <a:cubicBezTo>
                    <a:pt x="19" y="1304"/>
                    <a:pt x="0" y="1480"/>
                    <a:pt x="50" y="1520"/>
                  </a:cubicBezTo>
                  <a:cubicBezTo>
                    <a:pt x="63" y="1531"/>
                    <a:pt x="83" y="1534"/>
                    <a:pt x="98" y="1544"/>
                  </a:cubicBezTo>
                  <a:cubicBezTo>
                    <a:pt x="132" y="1648"/>
                    <a:pt x="210" y="1645"/>
                    <a:pt x="306" y="1656"/>
                  </a:cubicBezTo>
                  <a:cubicBezTo>
                    <a:pt x="359" y="1661"/>
                    <a:pt x="414" y="1670"/>
                    <a:pt x="466" y="1688"/>
                  </a:cubicBezTo>
                  <a:cubicBezTo>
                    <a:pt x="493" y="1697"/>
                    <a:pt x="517" y="1716"/>
                    <a:pt x="546" y="1720"/>
                  </a:cubicBezTo>
                  <a:cubicBezTo>
                    <a:pt x="644" y="1731"/>
                    <a:pt x="743" y="1729"/>
                    <a:pt x="842" y="1736"/>
                  </a:cubicBezTo>
                  <a:cubicBezTo>
                    <a:pt x="890" y="1748"/>
                    <a:pt x="901" y="1745"/>
                    <a:pt x="938" y="1768"/>
                  </a:cubicBezTo>
                  <a:cubicBezTo>
                    <a:pt x="981" y="1793"/>
                    <a:pt x="1036" y="1844"/>
                    <a:pt x="1090" y="1848"/>
                  </a:cubicBezTo>
                  <a:cubicBezTo>
                    <a:pt x="1156" y="1852"/>
                    <a:pt x="1223" y="1853"/>
                    <a:pt x="1290" y="1856"/>
                  </a:cubicBezTo>
                  <a:cubicBezTo>
                    <a:pt x="1320" y="1878"/>
                    <a:pt x="1344" y="1887"/>
                    <a:pt x="1378" y="1904"/>
                  </a:cubicBezTo>
                  <a:cubicBezTo>
                    <a:pt x="1383" y="1914"/>
                    <a:pt x="1387" y="1925"/>
                    <a:pt x="1394" y="1936"/>
                  </a:cubicBezTo>
                  <a:cubicBezTo>
                    <a:pt x="1403" y="1952"/>
                    <a:pt x="1426" y="1984"/>
                    <a:pt x="1426" y="1984"/>
                  </a:cubicBezTo>
                  <a:cubicBezTo>
                    <a:pt x="1438" y="2032"/>
                    <a:pt x="1442" y="2013"/>
                    <a:pt x="1482" y="2040"/>
                  </a:cubicBezTo>
                  <a:cubicBezTo>
                    <a:pt x="1519" y="2096"/>
                    <a:pt x="1511" y="2168"/>
                    <a:pt x="1530" y="2232"/>
                  </a:cubicBezTo>
                  <a:cubicBezTo>
                    <a:pt x="1532" y="2241"/>
                    <a:pt x="1541" y="2247"/>
                    <a:pt x="1546" y="2256"/>
                  </a:cubicBezTo>
                  <a:cubicBezTo>
                    <a:pt x="1562" y="2288"/>
                    <a:pt x="1573" y="2321"/>
                    <a:pt x="1594" y="2352"/>
                  </a:cubicBezTo>
                  <a:cubicBezTo>
                    <a:pt x="1596" y="2397"/>
                    <a:pt x="1595" y="2443"/>
                    <a:pt x="1602" y="2488"/>
                  </a:cubicBezTo>
                  <a:cubicBezTo>
                    <a:pt x="1603" y="2497"/>
                    <a:pt x="1615" y="2502"/>
                    <a:pt x="1618" y="2512"/>
                  </a:cubicBezTo>
                  <a:cubicBezTo>
                    <a:pt x="1633" y="2577"/>
                    <a:pt x="1633" y="2646"/>
                    <a:pt x="1650" y="2712"/>
                  </a:cubicBezTo>
                  <a:cubicBezTo>
                    <a:pt x="1656" y="2770"/>
                    <a:pt x="1665" y="2790"/>
                    <a:pt x="1682" y="2840"/>
                  </a:cubicBezTo>
                  <a:cubicBezTo>
                    <a:pt x="1697" y="2950"/>
                    <a:pt x="1717" y="3020"/>
                    <a:pt x="1762" y="3120"/>
                  </a:cubicBezTo>
                  <a:cubicBezTo>
                    <a:pt x="1791" y="3185"/>
                    <a:pt x="1768" y="3215"/>
                    <a:pt x="1842" y="3240"/>
                  </a:cubicBezTo>
                  <a:cubicBezTo>
                    <a:pt x="1851" y="3269"/>
                    <a:pt x="1841" y="3264"/>
                    <a:pt x="1866" y="3264"/>
                  </a:cubicBezTo>
                  <a:close/>
                </a:path>
              </a:pathLst>
            </a:custGeom>
            <a:solidFill>
              <a:srgbClr val="00ffff">
                <a:alpha val="30000"/>
              </a:srgbClr>
            </a:solidFill>
            <a:ln w="38160">
              <a:solidFill>
                <a:srgbClr val="00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" name=""/>
            <p:cNvSpPr/>
            <p:nvPr/>
          </p:nvSpPr>
          <p:spPr>
            <a:xfrm>
              <a:off x="258480" y="1676520"/>
              <a:ext cx="1645200" cy="825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400" spc="-1" strike="noStrike">
                  <a:solidFill>
                    <a:srgbClr val="ffffff"/>
                  </a:solidFill>
                  <a:latin typeface="Chalkboard Bold"/>
                  <a:ea typeface="ヒラギノ明朝 Pro W3"/>
                </a:rPr>
                <a:t>Focal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400" spc="-1" strike="noStrike">
                  <a:solidFill>
                    <a:srgbClr val="ffffff"/>
                  </a:solidFill>
                  <a:latin typeface="Chalkboard Bold"/>
                  <a:ea typeface="ヒラギノ明朝 Pro W3"/>
                </a:rPr>
                <a:t>adhesions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41" name=""/>
          <p:cNvGrpSpPr/>
          <p:nvPr/>
        </p:nvGrpSpPr>
        <p:grpSpPr>
          <a:xfrm>
            <a:off x="831960" y="851040"/>
            <a:ext cx="6508800" cy="5892840"/>
            <a:chOff x="831960" y="851040"/>
            <a:chExt cx="6508800" cy="5892840"/>
          </a:xfrm>
        </p:grpSpPr>
        <p:sp>
          <p:nvSpPr>
            <p:cNvPr id="42" name=""/>
            <p:cNvSpPr/>
            <p:nvPr/>
          </p:nvSpPr>
          <p:spPr>
            <a:xfrm>
              <a:off x="2120760" y="851040"/>
              <a:ext cx="5220000" cy="5892840"/>
            </a:xfrm>
            <a:custGeom>
              <a:avLst/>
              <a:gdLst/>
              <a:ahLst/>
              <a:rect l="l" t="t" r="r" b="b"/>
              <a:pathLst>
                <a:path w="3288" h="3712">
                  <a:moveTo>
                    <a:pt x="1456" y="24"/>
                  </a:moveTo>
                  <a:cubicBezTo>
                    <a:pt x="1492" y="17"/>
                    <a:pt x="1525" y="11"/>
                    <a:pt x="1560" y="0"/>
                  </a:cubicBezTo>
                  <a:cubicBezTo>
                    <a:pt x="1667" y="5"/>
                    <a:pt x="1764" y="17"/>
                    <a:pt x="1872" y="24"/>
                  </a:cubicBezTo>
                  <a:cubicBezTo>
                    <a:pt x="1914" y="34"/>
                    <a:pt x="1956" y="41"/>
                    <a:pt x="2000" y="48"/>
                  </a:cubicBezTo>
                  <a:cubicBezTo>
                    <a:pt x="2008" y="53"/>
                    <a:pt x="2015" y="59"/>
                    <a:pt x="2024" y="64"/>
                  </a:cubicBezTo>
                  <a:cubicBezTo>
                    <a:pt x="2031" y="67"/>
                    <a:pt x="2040" y="67"/>
                    <a:pt x="2048" y="72"/>
                  </a:cubicBezTo>
                  <a:cubicBezTo>
                    <a:pt x="2102" y="103"/>
                    <a:pt x="2152" y="146"/>
                    <a:pt x="2216" y="160"/>
                  </a:cubicBezTo>
                  <a:cubicBezTo>
                    <a:pt x="2255" y="168"/>
                    <a:pt x="2336" y="184"/>
                    <a:pt x="2336" y="184"/>
                  </a:cubicBezTo>
                  <a:cubicBezTo>
                    <a:pt x="2378" y="209"/>
                    <a:pt x="2408" y="232"/>
                    <a:pt x="2456" y="248"/>
                  </a:cubicBezTo>
                  <a:cubicBezTo>
                    <a:pt x="2472" y="253"/>
                    <a:pt x="2504" y="264"/>
                    <a:pt x="2504" y="264"/>
                  </a:cubicBezTo>
                  <a:cubicBezTo>
                    <a:pt x="2530" y="317"/>
                    <a:pt x="2551" y="304"/>
                    <a:pt x="2616" y="312"/>
                  </a:cubicBezTo>
                  <a:cubicBezTo>
                    <a:pt x="2651" y="333"/>
                    <a:pt x="2684" y="340"/>
                    <a:pt x="2720" y="360"/>
                  </a:cubicBezTo>
                  <a:cubicBezTo>
                    <a:pt x="2748" y="375"/>
                    <a:pt x="2798" y="402"/>
                    <a:pt x="2824" y="424"/>
                  </a:cubicBezTo>
                  <a:cubicBezTo>
                    <a:pt x="2832" y="431"/>
                    <a:pt x="2837" y="444"/>
                    <a:pt x="2848" y="448"/>
                  </a:cubicBezTo>
                  <a:cubicBezTo>
                    <a:pt x="2870" y="455"/>
                    <a:pt x="2896" y="453"/>
                    <a:pt x="2920" y="456"/>
                  </a:cubicBezTo>
                  <a:cubicBezTo>
                    <a:pt x="2945" y="468"/>
                    <a:pt x="3009" y="497"/>
                    <a:pt x="3032" y="520"/>
                  </a:cubicBezTo>
                  <a:cubicBezTo>
                    <a:pt x="3055" y="543"/>
                    <a:pt x="3072" y="557"/>
                    <a:pt x="3104" y="568"/>
                  </a:cubicBezTo>
                  <a:cubicBezTo>
                    <a:pt x="3122" y="623"/>
                    <a:pt x="3097" y="556"/>
                    <a:pt x="3136" y="624"/>
                  </a:cubicBezTo>
                  <a:cubicBezTo>
                    <a:pt x="3153" y="653"/>
                    <a:pt x="3153" y="667"/>
                    <a:pt x="3184" y="688"/>
                  </a:cubicBezTo>
                  <a:cubicBezTo>
                    <a:pt x="3220" y="743"/>
                    <a:pt x="3217" y="819"/>
                    <a:pt x="3248" y="880"/>
                  </a:cubicBezTo>
                  <a:cubicBezTo>
                    <a:pt x="3257" y="929"/>
                    <a:pt x="3275" y="974"/>
                    <a:pt x="3288" y="1024"/>
                  </a:cubicBezTo>
                  <a:cubicBezTo>
                    <a:pt x="3274" y="1132"/>
                    <a:pt x="3253" y="1146"/>
                    <a:pt x="3184" y="1216"/>
                  </a:cubicBezTo>
                  <a:cubicBezTo>
                    <a:pt x="3130" y="1269"/>
                    <a:pt x="3208" y="1213"/>
                    <a:pt x="3144" y="1256"/>
                  </a:cubicBezTo>
                  <a:cubicBezTo>
                    <a:pt x="3122" y="1288"/>
                    <a:pt x="3085" y="1323"/>
                    <a:pt x="3048" y="1336"/>
                  </a:cubicBezTo>
                  <a:cubicBezTo>
                    <a:pt x="2989" y="1409"/>
                    <a:pt x="2910" y="1448"/>
                    <a:pt x="2832" y="1496"/>
                  </a:cubicBezTo>
                  <a:cubicBezTo>
                    <a:pt x="2725" y="1559"/>
                    <a:pt x="2626" y="1607"/>
                    <a:pt x="2504" y="1632"/>
                  </a:cubicBezTo>
                  <a:cubicBezTo>
                    <a:pt x="2466" y="1650"/>
                    <a:pt x="2425" y="1662"/>
                    <a:pt x="2392" y="1688"/>
                  </a:cubicBezTo>
                  <a:cubicBezTo>
                    <a:pt x="2346" y="1721"/>
                    <a:pt x="2303" y="1748"/>
                    <a:pt x="2248" y="1760"/>
                  </a:cubicBezTo>
                  <a:cubicBezTo>
                    <a:pt x="2212" y="1777"/>
                    <a:pt x="2143" y="1808"/>
                    <a:pt x="2120" y="1840"/>
                  </a:cubicBezTo>
                  <a:cubicBezTo>
                    <a:pt x="2077" y="1896"/>
                    <a:pt x="2017" y="1936"/>
                    <a:pt x="1976" y="1992"/>
                  </a:cubicBezTo>
                  <a:cubicBezTo>
                    <a:pt x="1946" y="2031"/>
                    <a:pt x="1963" y="2016"/>
                    <a:pt x="1928" y="2040"/>
                  </a:cubicBezTo>
                  <a:cubicBezTo>
                    <a:pt x="1908" y="2068"/>
                    <a:pt x="1884" y="2092"/>
                    <a:pt x="1864" y="2120"/>
                  </a:cubicBezTo>
                  <a:cubicBezTo>
                    <a:pt x="1820" y="2249"/>
                    <a:pt x="1844" y="2331"/>
                    <a:pt x="1840" y="2504"/>
                  </a:cubicBezTo>
                  <a:cubicBezTo>
                    <a:pt x="1842" y="2624"/>
                    <a:pt x="1842" y="2744"/>
                    <a:pt x="1848" y="2864"/>
                  </a:cubicBezTo>
                  <a:cubicBezTo>
                    <a:pt x="1850" y="2914"/>
                    <a:pt x="1860" y="2965"/>
                    <a:pt x="1864" y="3016"/>
                  </a:cubicBezTo>
                  <a:cubicBezTo>
                    <a:pt x="1870" y="3109"/>
                    <a:pt x="1862" y="3125"/>
                    <a:pt x="1896" y="3192"/>
                  </a:cubicBezTo>
                  <a:cubicBezTo>
                    <a:pt x="1931" y="3367"/>
                    <a:pt x="1960" y="3607"/>
                    <a:pt x="1768" y="3672"/>
                  </a:cubicBezTo>
                  <a:cubicBezTo>
                    <a:pt x="1745" y="3706"/>
                    <a:pt x="1728" y="3703"/>
                    <a:pt x="1688" y="3712"/>
                  </a:cubicBezTo>
                  <a:cubicBezTo>
                    <a:pt x="1653" y="3709"/>
                    <a:pt x="1618" y="3708"/>
                    <a:pt x="1584" y="3704"/>
                  </a:cubicBezTo>
                  <a:cubicBezTo>
                    <a:pt x="1562" y="3700"/>
                    <a:pt x="1520" y="3688"/>
                    <a:pt x="1520" y="3688"/>
                  </a:cubicBezTo>
                  <a:cubicBezTo>
                    <a:pt x="1440" y="3635"/>
                    <a:pt x="1357" y="3643"/>
                    <a:pt x="1272" y="3608"/>
                  </a:cubicBezTo>
                  <a:cubicBezTo>
                    <a:pt x="1178" y="3569"/>
                    <a:pt x="1083" y="3516"/>
                    <a:pt x="984" y="3504"/>
                  </a:cubicBezTo>
                  <a:cubicBezTo>
                    <a:pt x="893" y="3443"/>
                    <a:pt x="777" y="3402"/>
                    <a:pt x="672" y="3376"/>
                  </a:cubicBezTo>
                  <a:cubicBezTo>
                    <a:pt x="651" y="3345"/>
                    <a:pt x="628" y="3341"/>
                    <a:pt x="600" y="3320"/>
                  </a:cubicBezTo>
                  <a:cubicBezTo>
                    <a:pt x="559" y="3289"/>
                    <a:pt x="466" y="3234"/>
                    <a:pt x="432" y="3200"/>
                  </a:cubicBezTo>
                  <a:cubicBezTo>
                    <a:pt x="409" y="3177"/>
                    <a:pt x="388" y="3153"/>
                    <a:pt x="368" y="3128"/>
                  </a:cubicBezTo>
                  <a:cubicBezTo>
                    <a:pt x="355" y="3112"/>
                    <a:pt x="354" y="3086"/>
                    <a:pt x="336" y="3080"/>
                  </a:cubicBezTo>
                  <a:cubicBezTo>
                    <a:pt x="292" y="3065"/>
                    <a:pt x="256" y="3044"/>
                    <a:pt x="216" y="3024"/>
                  </a:cubicBezTo>
                  <a:cubicBezTo>
                    <a:pt x="203" y="3004"/>
                    <a:pt x="186" y="2988"/>
                    <a:pt x="176" y="2968"/>
                  </a:cubicBezTo>
                  <a:cubicBezTo>
                    <a:pt x="168" y="2952"/>
                    <a:pt x="175" y="2927"/>
                    <a:pt x="160" y="2920"/>
                  </a:cubicBezTo>
                  <a:cubicBezTo>
                    <a:pt x="82" y="2881"/>
                    <a:pt x="116" y="2900"/>
                    <a:pt x="56" y="2864"/>
                  </a:cubicBezTo>
                  <a:cubicBezTo>
                    <a:pt x="33" y="2830"/>
                    <a:pt x="21" y="2800"/>
                    <a:pt x="0" y="2768"/>
                  </a:cubicBezTo>
                  <a:cubicBezTo>
                    <a:pt x="9" y="2712"/>
                    <a:pt x="24" y="2671"/>
                    <a:pt x="64" y="2632"/>
                  </a:cubicBezTo>
                  <a:cubicBezTo>
                    <a:pt x="73" y="2594"/>
                    <a:pt x="80" y="2581"/>
                    <a:pt x="112" y="2560"/>
                  </a:cubicBezTo>
                  <a:cubicBezTo>
                    <a:pt x="130" y="2532"/>
                    <a:pt x="144" y="2522"/>
                    <a:pt x="176" y="2512"/>
                  </a:cubicBezTo>
                  <a:cubicBezTo>
                    <a:pt x="188" y="2473"/>
                    <a:pt x="222" y="2438"/>
                    <a:pt x="256" y="2416"/>
                  </a:cubicBezTo>
                  <a:cubicBezTo>
                    <a:pt x="284" y="2373"/>
                    <a:pt x="347" y="2332"/>
                    <a:pt x="384" y="2296"/>
                  </a:cubicBezTo>
                  <a:cubicBezTo>
                    <a:pt x="423" y="2256"/>
                    <a:pt x="449" y="2206"/>
                    <a:pt x="488" y="2168"/>
                  </a:cubicBezTo>
                  <a:cubicBezTo>
                    <a:pt x="518" y="2137"/>
                    <a:pt x="588" y="2106"/>
                    <a:pt x="632" y="2096"/>
                  </a:cubicBezTo>
                  <a:cubicBezTo>
                    <a:pt x="692" y="2055"/>
                    <a:pt x="615" y="2102"/>
                    <a:pt x="688" y="2072"/>
                  </a:cubicBezTo>
                  <a:cubicBezTo>
                    <a:pt x="696" y="2068"/>
                    <a:pt x="703" y="2060"/>
                    <a:pt x="712" y="2056"/>
                  </a:cubicBezTo>
                  <a:cubicBezTo>
                    <a:pt x="719" y="2052"/>
                    <a:pt x="728" y="2050"/>
                    <a:pt x="736" y="2048"/>
                  </a:cubicBezTo>
                  <a:cubicBezTo>
                    <a:pt x="782" y="2001"/>
                    <a:pt x="843" y="1975"/>
                    <a:pt x="896" y="1936"/>
                  </a:cubicBezTo>
                  <a:cubicBezTo>
                    <a:pt x="906" y="1928"/>
                    <a:pt x="917" y="1919"/>
                    <a:pt x="928" y="1912"/>
                  </a:cubicBezTo>
                  <a:cubicBezTo>
                    <a:pt x="943" y="1900"/>
                    <a:pt x="976" y="1880"/>
                    <a:pt x="976" y="1880"/>
                  </a:cubicBezTo>
                  <a:cubicBezTo>
                    <a:pt x="978" y="1872"/>
                    <a:pt x="978" y="1862"/>
                    <a:pt x="984" y="1856"/>
                  </a:cubicBezTo>
                  <a:cubicBezTo>
                    <a:pt x="998" y="1838"/>
                    <a:pt x="1023" y="1831"/>
                    <a:pt x="1040" y="1816"/>
                  </a:cubicBezTo>
                  <a:cubicBezTo>
                    <a:pt x="1062" y="1795"/>
                    <a:pt x="1082" y="1773"/>
                    <a:pt x="1104" y="1752"/>
                  </a:cubicBezTo>
                  <a:cubicBezTo>
                    <a:pt x="1114" y="1741"/>
                    <a:pt x="1136" y="1720"/>
                    <a:pt x="1136" y="1720"/>
                  </a:cubicBezTo>
                  <a:cubicBezTo>
                    <a:pt x="1148" y="1682"/>
                    <a:pt x="1168" y="1690"/>
                    <a:pt x="1184" y="1656"/>
                  </a:cubicBezTo>
                  <a:cubicBezTo>
                    <a:pt x="1190" y="1640"/>
                    <a:pt x="1192" y="1623"/>
                    <a:pt x="1200" y="1608"/>
                  </a:cubicBezTo>
                  <a:cubicBezTo>
                    <a:pt x="1205" y="1597"/>
                    <a:pt x="1210" y="1586"/>
                    <a:pt x="1216" y="1576"/>
                  </a:cubicBezTo>
                  <a:cubicBezTo>
                    <a:pt x="1218" y="1464"/>
                    <a:pt x="1216" y="1351"/>
                    <a:pt x="1224" y="1240"/>
                  </a:cubicBezTo>
                  <a:cubicBezTo>
                    <a:pt x="1231" y="1124"/>
                    <a:pt x="1280" y="1345"/>
                    <a:pt x="1232" y="1136"/>
                  </a:cubicBezTo>
                  <a:cubicBezTo>
                    <a:pt x="1226" y="1113"/>
                    <a:pt x="1213" y="1094"/>
                    <a:pt x="1208" y="1072"/>
                  </a:cubicBezTo>
                  <a:cubicBezTo>
                    <a:pt x="1214" y="909"/>
                    <a:pt x="1210" y="905"/>
                    <a:pt x="1248" y="792"/>
                  </a:cubicBezTo>
                  <a:cubicBezTo>
                    <a:pt x="1206" y="582"/>
                    <a:pt x="1210" y="848"/>
                    <a:pt x="1240" y="328"/>
                  </a:cubicBezTo>
                  <a:cubicBezTo>
                    <a:pt x="1242" y="285"/>
                    <a:pt x="1261" y="222"/>
                    <a:pt x="1296" y="200"/>
                  </a:cubicBezTo>
                  <a:cubicBezTo>
                    <a:pt x="1309" y="179"/>
                    <a:pt x="1316" y="144"/>
                    <a:pt x="1336" y="128"/>
                  </a:cubicBezTo>
                  <a:cubicBezTo>
                    <a:pt x="1350" y="115"/>
                    <a:pt x="1384" y="96"/>
                    <a:pt x="1384" y="96"/>
                  </a:cubicBezTo>
                  <a:cubicBezTo>
                    <a:pt x="1389" y="88"/>
                    <a:pt x="1392" y="78"/>
                    <a:pt x="1400" y="72"/>
                  </a:cubicBezTo>
                  <a:cubicBezTo>
                    <a:pt x="1406" y="66"/>
                    <a:pt x="1418" y="69"/>
                    <a:pt x="1424" y="64"/>
                  </a:cubicBezTo>
                  <a:cubicBezTo>
                    <a:pt x="1466" y="21"/>
                    <a:pt x="1383" y="52"/>
                    <a:pt x="1464" y="32"/>
                  </a:cubicBezTo>
                  <a:cubicBezTo>
                    <a:pt x="1497" y="9"/>
                    <a:pt x="1497" y="13"/>
                    <a:pt x="1456" y="24"/>
                  </a:cubicBezTo>
                  <a:close/>
                </a:path>
              </a:pathLst>
            </a:custGeom>
            <a:solidFill>
              <a:srgbClr val="ffff00">
                <a:alpha val="30000"/>
              </a:srgbClr>
            </a:solidFill>
            <a:ln w="3816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831960" y="5867280"/>
              <a:ext cx="18554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400" spc="-1" strike="noStrike">
                  <a:solidFill>
                    <a:srgbClr val="ffffff"/>
                  </a:solidFill>
                  <a:latin typeface="Chalkboard Bold"/>
                  <a:ea typeface="ヒラギノ明朝 Pro W3"/>
                </a:rPr>
                <a:t>Podosomes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44" name=""/>
          <p:cNvGrpSpPr/>
          <p:nvPr/>
        </p:nvGrpSpPr>
        <p:grpSpPr>
          <a:xfrm>
            <a:off x="3882960" y="838080"/>
            <a:ext cx="5058000" cy="5892840"/>
            <a:chOff x="3882960" y="838080"/>
            <a:chExt cx="5058000" cy="5892840"/>
          </a:xfrm>
        </p:grpSpPr>
        <p:sp>
          <p:nvSpPr>
            <p:cNvPr id="45" name=""/>
            <p:cNvSpPr/>
            <p:nvPr/>
          </p:nvSpPr>
          <p:spPr>
            <a:xfrm>
              <a:off x="3882960" y="838080"/>
              <a:ext cx="3952800" cy="5892840"/>
            </a:xfrm>
            <a:custGeom>
              <a:avLst/>
              <a:gdLst/>
              <a:ahLst/>
              <a:rect l="l" t="t" r="r" b="b"/>
              <a:pathLst>
                <a:path w="2490" h="3712">
                  <a:moveTo>
                    <a:pt x="498" y="0"/>
                  </a:moveTo>
                  <a:cubicBezTo>
                    <a:pt x="457" y="27"/>
                    <a:pt x="401" y="32"/>
                    <a:pt x="354" y="48"/>
                  </a:cubicBezTo>
                  <a:cubicBezTo>
                    <a:pt x="338" y="53"/>
                    <a:pt x="322" y="58"/>
                    <a:pt x="306" y="64"/>
                  </a:cubicBezTo>
                  <a:cubicBezTo>
                    <a:pt x="298" y="66"/>
                    <a:pt x="282" y="72"/>
                    <a:pt x="282" y="72"/>
                  </a:cubicBezTo>
                  <a:cubicBezTo>
                    <a:pt x="276" y="80"/>
                    <a:pt x="272" y="89"/>
                    <a:pt x="266" y="96"/>
                  </a:cubicBezTo>
                  <a:cubicBezTo>
                    <a:pt x="259" y="102"/>
                    <a:pt x="248" y="104"/>
                    <a:pt x="242" y="112"/>
                  </a:cubicBezTo>
                  <a:cubicBezTo>
                    <a:pt x="236" y="118"/>
                    <a:pt x="237" y="128"/>
                    <a:pt x="234" y="136"/>
                  </a:cubicBezTo>
                  <a:cubicBezTo>
                    <a:pt x="220" y="163"/>
                    <a:pt x="198" y="188"/>
                    <a:pt x="186" y="216"/>
                  </a:cubicBezTo>
                  <a:cubicBezTo>
                    <a:pt x="165" y="261"/>
                    <a:pt x="148" y="313"/>
                    <a:pt x="130" y="360"/>
                  </a:cubicBezTo>
                  <a:cubicBezTo>
                    <a:pt x="139" y="813"/>
                    <a:pt x="124" y="1266"/>
                    <a:pt x="106" y="1720"/>
                  </a:cubicBezTo>
                  <a:cubicBezTo>
                    <a:pt x="103" y="2008"/>
                    <a:pt x="98" y="2295"/>
                    <a:pt x="98" y="2584"/>
                  </a:cubicBezTo>
                  <a:cubicBezTo>
                    <a:pt x="98" y="2832"/>
                    <a:pt x="0" y="3121"/>
                    <a:pt x="138" y="3328"/>
                  </a:cubicBezTo>
                  <a:cubicBezTo>
                    <a:pt x="143" y="3368"/>
                    <a:pt x="153" y="3401"/>
                    <a:pt x="162" y="3440"/>
                  </a:cubicBezTo>
                  <a:cubicBezTo>
                    <a:pt x="181" y="3529"/>
                    <a:pt x="201" y="3591"/>
                    <a:pt x="298" y="3624"/>
                  </a:cubicBezTo>
                  <a:cubicBezTo>
                    <a:pt x="348" y="3699"/>
                    <a:pt x="473" y="3704"/>
                    <a:pt x="554" y="3712"/>
                  </a:cubicBezTo>
                  <a:cubicBezTo>
                    <a:pt x="680" y="3705"/>
                    <a:pt x="767" y="3688"/>
                    <a:pt x="890" y="3672"/>
                  </a:cubicBezTo>
                  <a:cubicBezTo>
                    <a:pt x="929" y="3660"/>
                    <a:pt x="972" y="3647"/>
                    <a:pt x="1010" y="3632"/>
                  </a:cubicBezTo>
                  <a:cubicBezTo>
                    <a:pt x="1032" y="3622"/>
                    <a:pt x="1050" y="3605"/>
                    <a:pt x="1074" y="3600"/>
                  </a:cubicBezTo>
                  <a:cubicBezTo>
                    <a:pt x="1122" y="3587"/>
                    <a:pt x="1209" y="3554"/>
                    <a:pt x="1250" y="3528"/>
                  </a:cubicBezTo>
                  <a:cubicBezTo>
                    <a:pt x="1269" y="3515"/>
                    <a:pt x="1285" y="3498"/>
                    <a:pt x="1306" y="3488"/>
                  </a:cubicBezTo>
                  <a:cubicBezTo>
                    <a:pt x="1369" y="3456"/>
                    <a:pt x="1440" y="3436"/>
                    <a:pt x="1506" y="3408"/>
                  </a:cubicBezTo>
                  <a:cubicBezTo>
                    <a:pt x="1536" y="3394"/>
                    <a:pt x="1573" y="3383"/>
                    <a:pt x="1602" y="3368"/>
                  </a:cubicBezTo>
                  <a:cubicBezTo>
                    <a:pt x="1692" y="3317"/>
                    <a:pt x="1606" y="3352"/>
                    <a:pt x="1698" y="3312"/>
                  </a:cubicBezTo>
                  <a:cubicBezTo>
                    <a:pt x="1760" y="3284"/>
                    <a:pt x="1672" y="3332"/>
                    <a:pt x="1762" y="3288"/>
                  </a:cubicBezTo>
                  <a:cubicBezTo>
                    <a:pt x="1797" y="3270"/>
                    <a:pt x="1835" y="3256"/>
                    <a:pt x="1866" y="3232"/>
                  </a:cubicBezTo>
                  <a:cubicBezTo>
                    <a:pt x="1902" y="3202"/>
                    <a:pt x="1941" y="3166"/>
                    <a:pt x="1986" y="3152"/>
                  </a:cubicBezTo>
                  <a:cubicBezTo>
                    <a:pt x="2008" y="3107"/>
                    <a:pt x="2046" y="3081"/>
                    <a:pt x="2074" y="3040"/>
                  </a:cubicBezTo>
                  <a:cubicBezTo>
                    <a:pt x="2107" y="2989"/>
                    <a:pt x="2141" y="2944"/>
                    <a:pt x="2178" y="2896"/>
                  </a:cubicBezTo>
                  <a:cubicBezTo>
                    <a:pt x="2186" y="2872"/>
                    <a:pt x="2197" y="2848"/>
                    <a:pt x="2202" y="2824"/>
                  </a:cubicBezTo>
                  <a:cubicBezTo>
                    <a:pt x="2207" y="2792"/>
                    <a:pt x="2205" y="2757"/>
                    <a:pt x="2218" y="2728"/>
                  </a:cubicBezTo>
                  <a:cubicBezTo>
                    <a:pt x="2245" y="2663"/>
                    <a:pt x="2274" y="2598"/>
                    <a:pt x="2306" y="2536"/>
                  </a:cubicBezTo>
                  <a:cubicBezTo>
                    <a:pt x="2320" y="2461"/>
                    <a:pt x="2347" y="2365"/>
                    <a:pt x="2378" y="2296"/>
                  </a:cubicBezTo>
                  <a:cubicBezTo>
                    <a:pt x="2394" y="2257"/>
                    <a:pt x="2434" y="2184"/>
                    <a:pt x="2434" y="2184"/>
                  </a:cubicBezTo>
                  <a:cubicBezTo>
                    <a:pt x="2455" y="2076"/>
                    <a:pt x="2438" y="2169"/>
                    <a:pt x="2450" y="1944"/>
                  </a:cubicBezTo>
                  <a:cubicBezTo>
                    <a:pt x="2452" y="1901"/>
                    <a:pt x="2449" y="1857"/>
                    <a:pt x="2458" y="1816"/>
                  </a:cubicBezTo>
                  <a:cubicBezTo>
                    <a:pt x="2462" y="1792"/>
                    <a:pt x="2490" y="1752"/>
                    <a:pt x="2490" y="1752"/>
                  </a:cubicBezTo>
                  <a:cubicBezTo>
                    <a:pt x="2479" y="1658"/>
                    <a:pt x="2449" y="1572"/>
                    <a:pt x="2434" y="1480"/>
                  </a:cubicBezTo>
                  <a:cubicBezTo>
                    <a:pt x="2431" y="1424"/>
                    <a:pt x="2432" y="1367"/>
                    <a:pt x="2426" y="1312"/>
                  </a:cubicBezTo>
                  <a:cubicBezTo>
                    <a:pt x="2423" y="1290"/>
                    <a:pt x="2346" y="1216"/>
                    <a:pt x="2330" y="1192"/>
                  </a:cubicBezTo>
                  <a:cubicBezTo>
                    <a:pt x="2328" y="1178"/>
                    <a:pt x="2324" y="1131"/>
                    <a:pt x="2314" y="1112"/>
                  </a:cubicBezTo>
                  <a:cubicBezTo>
                    <a:pt x="2304" y="1095"/>
                    <a:pt x="2282" y="1064"/>
                    <a:pt x="2282" y="1064"/>
                  </a:cubicBezTo>
                  <a:cubicBezTo>
                    <a:pt x="2255" y="959"/>
                    <a:pt x="2184" y="922"/>
                    <a:pt x="2130" y="832"/>
                  </a:cubicBezTo>
                  <a:cubicBezTo>
                    <a:pt x="2093" y="771"/>
                    <a:pt x="2078" y="700"/>
                    <a:pt x="2042" y="640"/>
                  </a:cubicBezTo>
                  <a:cubicBezTo>
                    <a:pt x="2002" y="574"/>
                    <a:pt x="2010" y="608"/>
                    <a:pt x="1962" y="568"/>
                  </a:cubicBezTo>
                  <a:cubicBezTo>
                    <a:pt x="1895" y="512"/>
                    <a:pt x="1847" y="419"/>
                    <a:pt x="1754" y="400"/>
                  </a:cubicBezTo>
                  <a:cubicBezTo>
                    <a:pt x="1719" y="392"/>
                    <a:pt x="1684" y="394"/>
                    <a:pt x="1650" y="392"/>
                  </a:cubicBezTo>
                  <a:cubicBezTo>
                    <a:pt x="1630" y="372"/>
                    <a:pt x="1618" y="356"/>
                    <a:pt x="1594" y="344"/>
                  </a:cubicBezTo>
                  <a:cubicBezTo>
                    <a:pt x="1565" y="329"/>
                    <a:pt x="1533" y="331"/>
                    <a:pt x="1506" y="312"/>
                  </a:cubicBezTo>
                  <a:cubicBezTo>
                    <a:pt x="1446" y="269"/>
                    <a:pt x="1525" y="303"/>
                    <a:pt x="1442" y="272"/>
                  </a:cubicBezTo>
                  <a:cubicBezTo>
                    <a:pt x="1403" y="257"/>
                    <a:pt x="1322" y="248"/>
                    <a:pt x="1322" y="248"/>
                  </a:cubicBezTo>
                  <a:cubicBezTo>
                    <a:pt x="1288" y="214"/>
                    <a:pt x="1247" y="169"/>
                    <a:pt x="1202" y="152"/>
                  </a:cubicBezTo>
                  <a:cubicBezTo>
                    <a:pt x="1123" y="122"/>
                    <a:pt x="1013" y="111"/>
                    <a:pt x="930" y="104"/>
                  </a:cubicBezTo>
                  <a:cubicBezTo>
                    <a:pt x="875" y="76"/>
                    <a:pt x="918" y="93"/>
                    <a:pt x="842" y="80"/>
                  </a:cubicBezTo>
                  <a:cubicBezTo>
                    <a:pt x="801" y="72"/>
                    <a:pt x="762" y="56"/>
                    <a:pt x="722" y="48"/>
                  </a:cubicBezTo>
                  <a:cubicBezTo>
                    <a:pt x="633" y="3"/>
                    <a:pt x="618" y="7"/>
                    <a:pt x="498" y="0"/>
                  </a:cubicBezTo>
                  <a:close/>
                </a:path>
              </a:pathLst>
            </a:custGeom>
            <a:solidFill>
              <a:srgbClr val="ff00ff">
                <a:alpha val="30000"/>
              </a:srgbClr>
            </a:solidFill>
            <a:ln w="38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054920" y="5562720"/>
              <a:ext cx="18860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400" spc="-1" strike="noStrike">
                  <a:solidFill>
                    <a:srgbClr val="ffffff"/>
                  </a:solidFill>
                  <a:latin typeface="Chalkboard Bold"/>
                  <a:ea typeface="ヒラギノ明朝 Pro W3"/>
                </a:rPr>
                <a:t>Costameres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685800" y="-36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ffffff"/>
                </a:solidFill>
                <a:latin typeface="Comic Sans MS"/>
              </a:rPr>
              <a:t>Dystroglycan adhesion type interaction network</a:t>
            </a:r>
            <a:endParaRPr b="1" lang="en-US" sz="2400" spc="-1" strike="noStrike">
              <a:solidFill>
                <a:srgbClr val="ffffff"/>
              </a:solidFill>
              <a:latin typeface="Comic Sans MS"/>
            </a:endParaRPr>
          </a:p>
        </p:txBody>
      </p:sp>
      <p:grpSp>
        <p:nvGrpSpPr>
          <p:cNvPr id="48" name=""/>
          <p:cNvGrpSpPr/>
          <p:nvPr/>
        </p:nvGrpSpPr>
        <p:grpSpPr>
          <a:xfrm>
            <a:off x="2057040" y="2209680"/>
            <a:ext cx="5029200" cy="4038840"/>
            <a:chOff x="2057040" y="2209680"/>
            <a:chExt cx="5029200" cy="4038840"/>
          </a:xfrm>
        </p:grpSpPr>
        <p:grpSp>
          <p:nvGrpSpPr>
            <p:cNvPr id="49" name=""/>
            <p:cNvGrpSpPr/>
            <p:nvPr/>
          </p:nvGrpSpPr>
          <p:grpSpPr>
            <a:xfrm>
              <a:off x="2057040" y="2209680"/>
              <a:ext cx="5029200" cy="4038840"/>
              <a:chOff x="2057040" y="2209680"/>
              <a:chExt cx="5029200" cy="4038840"/>
            </a:xfrm>
          </p:grpSpPr>
          <p:sp>
            <p:nvSpPr>
              <p:cNvPr id="50" name=""/>
              <p:cNvSpPr/>
              <p:nvPr/>
            </p:nvSpPr>
            <p:spPr>
              <a:xfrm flipH="1">
                <a:off x="6400440" y="4343400"/>
                <a:ext cx="685800" cy="1066680"/>
              </a:xfrm>
              <a:prstGeom prst="line">
                <a:avLst/>
              </a:prstGeom>
              <a:ln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 flipH="1">
                <a:off x="4800240" y="5562720"/>
                <a:ext cx="1523880" cy="685800"/>
              </a:xfrm>
              <a:prstGeom prst="line">
                <a:avLst/>
              </a:prstGeom>
              <a:ln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H="1">
                <a:off x="2057040" y="2209680"/>
                <a:ext cx="762120" cy="1295640"/>
              </a:xfrm>
              <a:prstGeom prst="line">
                <a:avLst/>
              </a:prstGeom>
              <a:ln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2209680" y="3886200"/>
                <a:ext cx="2362320" cy="2286000"/>
              </a:xfrm>
              <a:prstGeom prst="line">
                <a:avLst/>
              </a:prstGeom>
              <a:ln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2971800" y="2209680"/>
                <a:ext cx="1600200" cy="3886200"/>
              </a:xfrm>
              <a:prstGeom prst="line">
                <a:avLst/>
              </a:prstGeom>
              <a:ln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55" name=""/>
            <p:cNvSpPr/>
            <p:nvPr/>
          </p:nvSpPr>
          <p:spPr>
            <a:xfrm flipH="1">
              <a:off x="6400440" y="2666880"/>
              <a:ext cx="152280" cy="2819520"/>
            </a:xfrm>
            <a:prstGeom prst="line">
              <a:avLst/>
            </a:prstGeom>
            <a:ln w="38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724280" y="3962520"/>
              <a:ext cx="0" cy="2057400"/>
            </a:xfrm>
            <a:prstGeom prst="line">
              <a:avLst/>
            </a:prstGeom>
            <a:ln w="38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895480" y="5410080"/>
              <a:ext cx="1524240" cy="838440"/>
            </a:xfrm>
            <a:prstGeom prst="line">
              <a:avLst/>
            </a:prstGeom>
            <a:ln w="38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58" name=""/>
          <p:cNvGrpSpPr/>
          <p:nvPr/>
        </p:nvGrpSpPr>
        <p:grpSpPr>
          <a:xfrm>
            <a:off x="1508040" y="826920"/>
            <a:ext cx="6167520" cy="5997960"/>
            <a:chOff x="1508040" y="826920"/>
            <a:chExt cx="6167520" cy="5997960"/>
          </a:xfrm>
        </p:grpSpPr>
        <p:grpSp>
          <p:nvGrpSpPr>
            <p:cNvPr id="59" name=""/>
            <p:cNvGrpSpPr/>
            <p:nvPr/>
          </p:nvGrpSpPr>
          <p:grpSpPr>
            <a:xfrm>
              <a:off x="2209680" y="1600200"/>
              <a:ext cx="4800240" cy="4648320"/>
              <a:chOff x="2209680" y="1600200"/>
              <a:chExt cx="4800240" cy="4648320"/>
            </a:xfrm>
          </p:grpSpPr>
          <p:sp>
            <p:nvSpPr>
              <p:cNvPr id="60" name=""/>
              <p:cNvSpPr/>
              <p:nvPr/>
            </p:nvSpPr>
            <p:spPr>
              <a:xfrm>
                <a:off x="4572000" y="1600200"/>
                <a:ext cx="0" cy="4648320"/>
              </a:xfrm>
              <a:prstGeom prst="line">
                <a:avLst/>
              </a:prstGeom>
              <a:ln w="381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2209680" y="3657600"/>
                <a:ext cx="2438640" cy="76320"/>
              </a:xfrm>
              <a:prstGeom prst="line">
                <a:avLst/>
              </a:prstGeom>
              <a:ln w="381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 flipH="1">
                <a:off x="4572000" y="2438640"/>
                <a:ext cx="1905120" cy="1295280"/>
              </a:xfrm>
              <a:prstGeom prst="line">
                <a:avLst/>
              </a:prstGeom>
              <a:ln w="381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H="1" flipV="1">
                <a:off x="4647960" y="3733560"/>
                <a:ext cx="2361960" cy="304920"/>
              </a:xfrm>
              <a:prstGeom prst="line">
                <a:avLst/>
              </a:prstGeom>
              <a:ln w="381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 flipH="1" flipV="1">
                <a:off x="4647960" y="3809880"/>
                <a:ext cx="1600200" cy="1523880"/>
              </a:xfrm>
              <a:prstGeom prst="line">
                <a:avLst/>
              </a:prstGeom>
              <a:ln w="381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 flipV="1">
                <a:off x="2666880" y="3810240"/>
                <a:ext cx="1752840" cy="1218960"/>
              </a:xfrm>
              <a:prstGeom prst="line">
                <a:avLst/>
              </a:prstGeom>
              <a:ln w="381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895480" y="2057400"/>
                <a:ext cx="1676520" cy="1676520"/>
              </a:xfrm>
              <a:prstGeom prst="line">
                <a:avLst/>
              </a:prstGeom>
              <a:ln w="381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971800" y="2057400"/>
                <a:ext cx="3505320" cy="304920"/>
              </a:xfrm>
              <a:prstGeom prst="line">
                <a:avLst/>
              </a:prstGeom>
              <a:ln w="381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H="1">
                <a:off x="6248160" y="2514600"/>
                <a:ext cx="152280" cy="3048120"/>
              </a:xfrm>
              <a:prstGeom prst="line">
                <a:avLst/>
              </a:prstGeom>
              <a:ln w="381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819520" y="5257800"/>
                <a:ext cx="1676160" cy="914400"/>
              </a:xfrm>
              <a:prstGeom prst="line">
                <a:avLst/>
              </a:prstGeom>
              <a:ln w="381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70" name=""/>
            <p:cNvGrpSpPr/>
            <p:nvPr/>
          </p:nvGrpSpPr>
          <p:grpSpPr>
            <a:xfrm>
              <a:off x="1508040" y="826920"/>
              <a:ext cx="6167520" cy="5997960"/>
              <a:chOff x="1508040" y="826920"/>
              <a:chExt cx="6167520" cy="5997960"/>
            </a:xfrm>
          </p:grpSpPr>
          <p:sp>
            <p:nvSpPr>
              <p:cNvPr id="71" name=""/>
              <p:cNvSpPr/>
              <p:nvPr/>
            </p:nvSpPr>
            <p:spPr>
              <a:xfrm rot="1590600">
                <a:off x="6080040" y="1990440"/>
                <a:ext cx="838440" cy="838080"/>
              </a:xfrm>
              <a:prstGeom prst="ellipse">
                <a:avLst/>
              </a:prstGeom>
              <a:solidFill>
                <a:srgbClr val="000000"/>
              </a:solidFill>
              <a:ln w="2844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rot="1590600">
                <a:off x="6694560" y="3660480"/>
                <a:ext cx="838080" cy="838080"/>
              </a:xfrm>
              <a:prstGeom prst="ellipse">
                <a:avLst/>
              </a:prstGeom>
              <a:solidFill>
                <a:srgbClr val="000000"/>
              </a:solidFill>
              <a:ln w="2844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rot="1590600">
                <a:off x="5946480" y="5160600"/>
                <a:ext cx="838080" cy="838440"/>
              </a:xfrm>
              <a:prstGeom prst="ellipse">
                <a:avLst/>
              </a:prstGeom>
              <a:solidFill>
                <a:srgbClr val="000000"/>
              </a:solidFill>
              <a:ln w="2844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 rot="1590600">
                <a:off x="4243320" y="5843520"/>
                <a:ext cx="838440" cy="838080"/>
              </a:xfrm>
              <a:prstGeom prst="ellipse">
                <a:avLst/>
              </a:prstGeom>
              <a:solidFill>
                <a:srgbClr val="000000"/>
              </a:solidFill>
              <a:ln w="2844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 rot="1590600">
                <a:off x="2300040" y="4789080"/>
                <a:ext cx="838080" cy="838440"/>
              </a:xfrm>
              <a:prstGeom prst="ellipse">
                <a:avLst/>
              </a:prstGeom>
              <a:solidFill>
                <a:srgbClr val="000000"/>
              </a:solidFill>
              <a:ln w="2844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rot="1590600">
                <a:off x="1650960" y="3187440"/>
                <a:ext cx="838080" cy="838080"/>
              </a:xfrm>
              <a:prstGeom prst="ellipse">
                <a:avLst/>
              </a:prstGeom>
              <a:solidFill>
                <a:srgbClr val="000000"/>
              </a:solidFill>
              <a:ln w="2844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 rot="1590600">
                <a:off x="2467080" y="1550880"/>
                <a:ext cx="838080" cy="838080"/>
              </a:xfrm>
              <a:prstGeom prst="ellipse">
                <a:avLst/>
              </a:prstGeom>
              <a:solidFill>
                <a:srgbClr val="000000"/>
              </a:solidFill>
              <a:ln w="2844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rot="1590600">
                <a:off x="4205160" y="969840"/>
                <a:ext cx="838440" cy="838080"/>
              </a:xfrm>
              <a:prstGeom prst="ellipse">
                <a:avLst/>
              </a:prstGeom>
              <a:solidFill>
                <a:srgbClr val="000000"/>
              </a:solidFill>
              <a:ln w="2844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rot="1590600">
                <a:off x="4138560" y="3322440"/>
                <a:ext cx="838080" cy="838080"/>
              </a:xfrm>
              <a:prstGeom prst="ellipse">
                <a:avLst/>
              </a:prstGeom>
              <a:solidFill>
                <a:srgbClr val="000000"/>
              </a:solidFill>
              <a:ln w="2844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4251240" y="3504960"/>
                <a:ext cx="62568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2400" spc="-1" strike="noStrike">
                    <a:solidFill>
                      <a:srgbClr val="ffffff"/>
                    </a:solidFill>
                    <a:latin typeface="Chalkboard Bold"/>
                    <a:ea typeface="ヒラギノ明朝 Pro W3"/>
                  </a:rPr>
                  <a:t>DG</a:t>
                </a: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6035040" y="2209680"/>
                <a:ext cx="9014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ffffff"/>
                    </a:solidFill>
                    <a:latin typeface="Chalkboard Bold"/>
                    <a:ea typeface="ヒラギノ明朝 Pro W3"/>
                  </a:rPr>
                  <a:t>Plectin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6729120" y="3885840"/>
                <a:ext cx="7736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ffffff"/>
                    </a:solidFill>
                    <a:latin typeface="Chalkboard Bold"/>
                    <a:ea typeface="ヒラギノ明朝 Pro W3"/>
                  </a:rPr>
                  <a:t>Cav-3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5639400" y="5410080"/>
                <a:ext cx="16117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ffffff"/>
                    </a:solidFill>
                    <a:latin typeface="Chalkboard Bold"/>
                    <a:ea typeface="ヒラギノ明朝 Pro W3"/>
                  </a:rPr>
                  <a:t> </a:t>
                </a:r>
                <a:r>
                  <a:rPr b="0" lang="en-GB" sz="1800" spc="-1" strike="noStrike">
                    <a:solidFill>
                      <a:srgbClr val="ffffff"/>
                    </a:solidFill>
                    <a:latin typeface="Chalkboard Bold"/>
                    <a:ea typeface="ヒラギノ明朝 Pro W3"/>
                  </a:rPr>
                  <a:t>Dystrophin   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4437720" y="6095880"/>
                <a:ext cx="509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ffffff"/>
                    </a:solidFill>
                    <a:latin typeface="Chalkboard Bold"/>
                    <a:ea typeface="ヒラギノ明朝 Pro W3"/>
                  </a:rPr>
                  <a:t>Src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2371680" y="5028840"/>
                <a:ext cx="6699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ffffff"/>
                    </a:solidFill>
                    <a:latin typeface="Chalkboard Bold"/>
                    <a:ea typeface="ヒラギノ明朝 Pro W3"/>
                  </a:rPr>
                  <a:t>Tks5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1596240" y="3428640"/>
                <a:ext cx="970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ffffff"/>
                    </a:solidFill>
                    <a:latin typeface="Chalkboard Bold"/>
                    <a:ea typeface="ヒラギノ明朝 Pro W3"/>
                  </a:rPr>
                  <a:t>Vinexin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300760" y="1752480"/>
                <a:ext cx="11469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ffffff"/>
                    </a:solidFill>
                    <a:latin typeface="Chalkboard Bold"/>
                    <a:ea typeface="ヒラギノ明朝 Pro W3"/>
                  </a:rPr>
                  <a:t>Utrophin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4276800" y="1218960"/>
                <a:ext cx="711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ffffff"/>
                    </a:solidFill>
                    <a:latin typeface="Chalkboard Bold"/>
                    <a:ea typeface="ヒラギノ明朝 Pro W3"/>
                  </a:rPr>
                  <a:t>Ezrin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7" dur="2000"/>
                                        <p:tgtEl>
                                          <p:spTgt spid="4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nodeType="click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2" dur="20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nodeType="click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7" dur="200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nodeType="click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2" dur="2000"/>
                                        <p:tgtEl>
                                          <p:spTgt spid="4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steve</dc:creator>
  <dc:description/>
  <cp:keywords/>
  <dc:language>en-US</dc:language>
  <cp:lastModifiedBy>steve</cp:lastModifiedBy>
  <dcterms:modified xsi:type="dcterms:W3CDTF">2010-01-28T20:57:56Z</dcterms:modified>
  <cp:revision>53</cp:revision>
  <dc:subject/>
  <dc:title>PowerPoint Presentation</dc:title>
</cp:coreProperties>
</file>